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955"/>
    <p:restoredTop sz="94724"/>
  </p:normalViewPr>
  <p:slideViewPr>
    <p:cSldViewPr snapToGrid="0" snapToObjects="1">
      <p:cViewPr varScale="1">
        <p:scale>
          <a:sx n="103" d="100"/>
          <a:sy n="103" d="100"/>
        </p:scale>
        <p:origin x="25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DEC2AB1-70AB-C443-B54E-5ECFC0EBB5D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E9B1849E-2E32-F84D-A639-55623633B31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E69F669-938E-3047-8C04-F11D29BC5D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F1CF7-017F-7444-9766-62A01893CC6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A6835F8-9C6B-7F4F-A70D-06B18D1CF4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EDC651B-5EBA-3545-82D3-AA33F18BFF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3EB5-B6F7-F943-B17D-C960BFDA81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016678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9177237-CD8F-5443-AA8D-6F84D8E819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20CF06A9-CD6B-384D-8B4D-35225D617D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BEF805E-889E-4B4F-AE9E-C7C828A470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F1CF7-017F-7444-9766-62A01893CC6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A2C0417-144E-3A4C-80FC-D98BF82915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B16BECA-EBA2-FA45-B537-FB1BEFD784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3EB5-B6F7-F943-B17D-C960BFDA81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13786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1C44CDE1-1274-5D40-9717-8ED0ED8237C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64D9677-6A8D-D045-AE4D-DB3F22F572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9185042-F29C-BC48-AE02-5DF7405236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F1CF7-017F-7444-9766-62A01893CC6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29D676E-CB77-F447-96DE-31EA8A4588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E50F4AE-1D8A-A64E-8050-7573C1A01B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3EB5-B6F7-F943-B17D-C960BFDA81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4756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1736409-1C99-D94E-954E-866B6AEF7A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E06629B-8321-924F-8840-B86AFE0DCA2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1E87C73-1010-2F42-8984-F71F547B49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F1CF7-017F-7444-9766-62A01893CC6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CFC8334-7DB5-5842-A6AD-4C7B26F8FB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5BD7D68-F13B-894E-845D-7DA1A977D7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3EB5-B6F7-F943-B17D-C960BFDA81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450259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88E1180-35C9-AD48-884D-87352F52F5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1448EF7-CA14-854C-931D-A326257C63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2C02947-2D9C-1347-B1E1-760350DB17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F1CF7-017F-7444-9766-62A01893CC6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5076D01-EC96-F54F-8F0E-2273076AD8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48C1263-516C-404C-92FF-046B6C7A4A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3EB5-B6F7-F943-B17D-C960BFDA81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928318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507A71C-D699-D947-B7D1-CB564321AE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69C165C-9CA2-5642-B54D-0D33DEA2340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1BA67BFE-F41A-8446-B7BF-5DE085DB54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56AF527-422E-1A4F-9AD0-4E6043E24E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F1CF7-017F-7444-9766-62A01893CC6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8F5DF91-3689-314D-BA32-AD7F492516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6EC4823-3356-894F-998C-BB1CDB28AB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3EB5-B6F7-F943-B17D-C960BFDA81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818567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5B6FB8B-AE41-A040-A2C7-B8F1EA7437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B15025CC-15D4-194E-84C2-66A58E3CD8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64F9D588-53CA-3942-96F7-477D97C8D16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81528BDC-B3B0-804C-9B4B-C04353E68EA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97E43629-853C-0C4E-B0E4-2C2B78478A5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661B0C5B-5637-EC42-8F07-852B932B8B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F1CF7-017F-7444-9766-62A01893CC6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38957272-9BFF-714E-80D3-6C8FEED322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F919584B-E1CE-1C46-B281-5CDA808D5E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3EB5-B6F7-F943-B17D-C960BFDA81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16260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070DBA3-1257-DE4B-BC64-6952E03E2A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8F38C9CB-DE0B-9D4E-BE9D-35357F2E3D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F1CF7-017F-7444-9766-62A01893CC6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41CD25A5-F04E-D34C-90F9-9B27A1F312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890E122C-8B36-A24A-B577-C3CD3CA915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3EB5-B6F7-F943-B17D-C960BFDA81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568099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9F401E5D-7016-8043-9941-CE98BAF0A1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F1CF7-017F-7444-9766-62A01893CC6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92E4BA36-6938-EC46-997E-78084F8B0B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0512CA8E-45BD-6749-91E1-901AE71D0D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3EB5-B6F7-F943-B17D-C960BFDA81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55623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A88A9FD-0B72-7349-8733-E4EEE96ED9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30AE7FA-944D-3E44-9736-A3154796526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D39501A8-784B-664B-8115-1F8521830A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1AB01C1-2226-AA44-989C-4B9EB30F32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F1CF7-017F-7444-9766-62A01893CC6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162EF7A-7EFD-CE4C-8926-44E0C0743F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0D45A3F-5914-834C-B00A-DA943E7E57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3EB5-B6F7-F943-B17D-C960BFDA81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54000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65C2C3A-8672-5542-8C03-D89AEF358B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FEA1C5EC-098D-914C-A169-C58B2E49BA0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58C5BFA-C7B4-3A4B-8D65-2A58EBA3C9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F67409D-6EE0-5D40-B3B1-93D5A651AD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F1CF7-017F-7444-9766-62A01893CC6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870C938-E12C-D748-9C39-3E8A849C78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A917A16-E9BD-0744-ADA4-3256138BEB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7A3EB5-B6F7-F943-B17D-C960BFDA81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118133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F17C31FA-BB1B-A54D-BF6D-EBD092AD13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02A01B6-7963-9A49-B04C-A4A8C6D390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C9D0D9D-826F-744C-80F4-4C74B8942D5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1F1CF7-017F-7444-9766-62A01893CC6E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31E204D-6E97-8742-B686-CA6A53E3D7D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CB227F5-2DA0-F341-9098-B219B472B89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7A3EB5-B6F7-F943-B17D-C960BFDA812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63513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41973E8B-0AEA-0948-91A7-6A157525F36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7683" y="1233961"/>
            <a:ext cx="5555312" cy="5567082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155F49D3-1BE5-314C-8841-25689206814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60036" y="1233961"/>
            <a:ext cx="5537199" cy="5560712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FE90BE3B-BD6C-1440-BCBF-39DB2F129881}"/>
              </a:ext>
            </a:extLst>
          </p:cNvPr>
          <p:cNvSpPr txBox="1"/>
          <p:nvPr/>
        </p:nvSpPr>
        <p:spPr>
          <a:xfrm>
            <a:off x="0" y="15103"/>
            <a:ext cx="121920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1: Gpr101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verexpression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in the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ituitary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omotes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Gh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/Igf-1 and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olactin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hypersecretion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keletal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vergrowth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in vivo</a:t>
            </a:r>
          </a:p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Panel K</a:t>
            </a:r>
          </a:p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CT images of WT (+/+) and </a:t>
            </a:r>
            <a:r>
              <a:rPr lang="fr-FR" sz="1400" i="1" dirty="0">
                <a:latin typeface="Arial" panose="020B0604020202020204" pitchFamily="34" charset="0"/>
                <a:cs typeface="Arial" panose="020B0604020202020204" pitchFamily="34" charset="0"/>
              </a:rPr>
              <a:t>Ghrhr</a:t>
            </a:r>
            <a:r>
              <a:rPr lang="fr-FR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Gpr101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(+/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body stature (27-week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, males)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5BF19698-80F9-1442-B12A-5BC3391B54EB}"/>
              </a:ext>
            </a:extLst>
          </p:cNvPr>
          <p:cNvSpPr txBox="1"/>
          <p:nvPr/>
        </p:nvSpPr>
        <p:spPr>
          <a:xfrm>
            <a:off x="207683" y="1233961"/>
            <a:ext cx="6624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solidFill>
                  <a:schemeClr val="bg1"/>
                </a:solidFill>
              </a:rPr>
              <a:t>+/+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98ACB61F-79DB-F14F-A4D0-28A7C8C49A89}"/>
              </a:ext>
            </a:extLst>
          </p:cNvPr>
          <p:cNvSpPr txBox="1"/>
          <p:nvPr/>
        </p:nvSpPr>
        <p:spPr>
          <a:xfrm>
            <a:off x="5960036" y="1233961"/>
            <a:ext cx="6624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solidFill>
                  <a:schemeClr val="bg1"/>
                </a:solidFill>
              </a:rPr>
              <a:t>+/</a:t>
            </a:r>
            <a:r>
              <a:rPr lang="fr-FR" b="1" dirty="0" err="1">
                <a:solidFill>
                  <a:schemeClr val="bg1"/>
                </a:solidFill>
              </a:rPr>
              <a:t>T</a:t>
            </a:r>
            <a:endParaRPr lang="fr-FR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39836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1B95C027-D2A6-0D4C-8164-51914F673523}"/>
              </a:ext>
            </a:extLst>
          </p:cNvPr>
          <p:cNvPicPr>
            <a:picLocks/>
          </p:cNvPicPr>
          <p:nvPr/>
        </p:nvPicPr>
        <p:blipFill rotWithShape="1">
          <a:blip r:embed="rId2"/>
          <a:srcRect l="45504" t="9969" r="388" b="60360"/>
          <a:stretch/>
        </p:blipFill>
        <p:spPr>
          <a:xfrm>
            <a:off x="3628103" y="1194619"/>
            <a:ext cx="4321277" cy="2198206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C007B74E-8A47-E846-9CD4-61943334D471}"/>
              </a:ext>
            </a:extLst>
          </p:cNvPr>
          <p:cNvPicPr>
            <a:picLocks/>
          </p:cNvPicPr>
          <p:nvPr/>
        </p:nvPicPr>
        <p:blipFill rotWithShape="1">
          <a:blip r:embed="rId3"/>
          <a:srcRect l="42319" t="12812" b="59870"/>
          <a:stretch/>
        </p:blipFill>
        <p:spPr>
          <a:xfrm>
            <a:off x="3628104" y="3598605"/>
            <a:ext cx="4321276" cy="2374491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44119DA2-E724-6A41-94C3-C01A8F33D013}"/>
              </a:ext>
            </a:extLst>
          </p:cNvPr>
          <p:cNvSpPr txBox="1"/>
          <p:nvPr/>
        </p:nvSpPr>
        <p:spPr>
          <a:xfrm>
            <a:off x="3628103" y="1194619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26071BC8-09F7-1043-AE24-3D279765210B}"/>
              </a:ext>
            </a:extLst>
          </p:cNvPr>
          <p:cNvSpPr txBox="1"/>
          <p:nvPr/>
        </p:nvSpPr>
        <p:spPr>
          <a:xfrm>
            <a:off x="3572532" y="3598605"/>
            <a:ext cx="5245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/</a:t>
            </a:r>
            <a:r>
              <a:rPr lang="fr-FR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fr-FR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3B5A853D-95C2-1947-89C1-FD1866255259}"/>
              </a:ext>
            </a:extLst>
          </p:cNvPr>
          <p:cNvSpPr txBox="1"/>
          <p:nvPr/>
        </p:nvSpPr>
        <p:spPr>
          <a:xfrm>
            <a:off x="0" y="15103"/>
            <a:ext cx="121920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1: Gpr101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verexpression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in the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ituitary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omotes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GH/IGF-1 and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olactin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hypersecretion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keletal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vergrowth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in vivo</a:t>
            </a:r>
          </a:p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Panel K</a:t>
            </a:r>
          </a:p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CT images of WT (+/+) and </a:t>
            </a:r>
            <a:r>
              <a:rPr lang="fr-FR" sz="1400" i="1" dirty="0">
                <a:latin typeface="Arial" panose="020B0604020202020204" pitchFamily="34" charset="0"/>
                <a:cs typeface="Arial" panose="020B0604020202020204" pitchFamily="34" charset="0"/>
              </a:rPr>
              <a:t>Ghrhr</a:t>
            </a:r>
            <a:r>
              <a:rPr lang="fr-FR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Gpr101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(+/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body stature (27-week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, males)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2D3E5963-17DC-1043-B68B-4C33790C3A84}"/>
              </a:ext>
            </a:extLst>
          </p:cNvPr>
          <p:cNvSpPr txBox="1"/>
          <p:nvPr/>
        </p:nvSpPr>
        <p:spPr>
          <a:xfrm>
            <a:off x="4379683" y="3686082"/>
            <a:ext cx="1133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ephosis</a:t>
            </a:r>
            <a:endParaRPr lang="fr-FR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Connecteur droit avec flèche 8">
            <a:extLst>
              <a:ext uri="{FF2B5EF4-FFF2-40B4-BE49-F238E27FC236}">
                <a16:creationId xmlns:a16="http://schemas.microsoft.com/office/drawing/2014/main" id="{1590A78D-C318-C14C-A131-FA44E364024D}"/>
              </a:ext>
            </a:extLst>
          </p:cNvPr>
          <p:cNvCxnSpPr>
            <a:cxnSpLocks/>
          </p:cNvCxnSpPr>
          <p:nvPr/>
        </p:nvCxnSpPr>
        <p:spPr>
          <a:xfrm>
            <a:off x="5504956" y="3967937"/>
            <a:ext cx="283785" cy="256186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necteur droit avec flèche 11">
            <a:extLst>
              <a:ext uri="{FF2B5EF4-FFF2-40B4-BE49-F238E27FC236}">
                <a16:creationId xmlns:a16="http://schemas.microsoft.com/office/drawing/2014/main" id="{B5BF423A-EA1F-0140-8213-F7B624D1D9CC}"/>
              </a:ext>
            </a:extLst>
          </p:cNvPr>
          <p:cNvCxnSpPr>
            <a:cxnSpLocks/>
          </p:cNvCxnSpPr>
          <p:nvPr/>
        </p:nvCxnSpPr>
        <p:spPr>
          <a:xfrm>
            <a:off x="5504523" y="1791907"/>
            <a:ext cx="283785" cy="256186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necteur droit avec flèche 12">
            <a:extLst>
              <a:ext uri="{FF2B5EF4-FFF2-40B4-BE49-F238E27FC236}">
                <a16:creationId xmlns:a16="http://schemas.microsoft.com/office/drawing/2014/main" id="{A8D80402-7D43-5E4B-A0F8-3FED609A6F3D}"/>
              </a:ext>
            </a:extLst>
          </p:cNvPr>
          <p:cNvCxnSpPr>
            <a:cxnSpLocks/>
          </p:cNvCxnSpPr>
          <p:nvPr/>
        </p:nvCxnSpPr>
        <p:spPr>
          <a:xfrm>
            <a:off x="6233572" y="2306079"/>
            <a:ext cx="436185" cy="0"/>
          </a:xfrm>
          <a:prstGeom prst="straightConnector1">
            <a:avLst/>
          </a:prstGeom>
          <a:ln>
            <a:solidFill>
              <a:srgbClr val="00FA0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necteur droit avec flèche 14">
            <a:extLst>
              <a:ext uri="{FF2B5EF4-FFF2-40B4-BE49-F238E27FC236}">
                <a16:creationId xmlns:a16="http://schemas.microsoft.com/office/drawing/2014/main" id="{7F3F264C-681B-9641-9B37-6876F903AE57}"/>
              </a:ext>
            </a:extLst>
          </p:cNvPr>
          <p:cNvCxnSpPr>
            <a:cxnSpLocks/>
          </p:cNvCxnSpPr>
          <p:nvPr/>
        </p:nvCxnSpPr>
        <p:spPr>
          <a:xfrm>
            <a:off x="6233572" y="4785850"/>
            <a:ext cx="436185" cy="0"/>
          </a:xfrm>
          <a:prstGeom prst="straightConnector1">
            <a:avLst/>
          </a:prstGeom>
          <a:ln>
            <a:solidFill>
              <a:srgbClr val="00FA0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ZoneTexte 15">
            <a:extLst>
              <a:ext uri="{FF2B5EF4-FFF2-40B4-BE49-F238E27FC236}">
                <a16:creationId xmlns:a16="http://schemas.microsoft.com/office/drawing/2014/main" id="{3A0088AC-E7C8-7745-B921-63E80419FDE1}"/>
              </a:ext>
            </a:extLst>
          </p:cNvPr>
          <p:cNvSpPr txBox="1"/>
          <p:nvPr/>
        </p:nvSpPr>
        <p:spPr>
          <a:xfrm>
            <a:off x="5463689" y="5247886"/>
            <a:ext cx="14670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ng </a:t>
            </a:r>
            <a:r>
              <a:rPr lang="fr-FR" dirty="0" err="1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emurs</a:t>
            </a:r>
            <a:endParaRPr lang="fr-FR" dirty="0">
              <a:solidFill>
                <a:srgbClr val="00FA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4758381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91</Words>
  <Application>Microsoft Macintosh PowerPoint</Application>
  <PresentationFormat>Grand écran</PresentationFormat>
  <Paragraphs>12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Microsoft Office</dc:creator>
  <cp:lastModifiedBy>Utilisateur Microsoft Office</cp:lastModifiedBy>
  <cp:revision>4</cp:revision>
  <dcterms:created xsi:type="dcterms:W3CDTF">2020-05-10T10:31:28Z</dcterms:created>
  <dcterms:modified xsi:type="dcterms:W3CDTF">2020-05-25T17:46:57Z</dcterms:modified>
</cp:coreProperties>
</file>